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FF00"/>
    <a:srgbClr val="329A00"/>
    <a:srgbClr val="FAFAFA"/>
    <a:srgbClr val="C16F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596" autoAdjust="0"/>
    <p:restoredTop sz="93673"/>
  </p:normalViewPr>
  <p:slideViewPr>
    <p:cSldViewPr snapToGrid="0">
      <p:cViewPr varScale="1">
        <p:scale>
          <a:sx n="83" d="100"/>
          <a:sy n="83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20B807-FFFC-4DAC-8EA2-95DE491FEF45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12ECE4-AFA1-4EBA-B4A4-F476D2DEAF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4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2ECE4-AFA1-4EBA-B4A4-F476D2DEAFF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8474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5325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1989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5492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5859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5784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4179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2089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5114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3346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03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3339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6A6B5-8B81-4536-B3A0-F4A0942625AD}" type="datetimeFigureOut">
              <a:rPr lang="de-DE" smtClean="0"/>
              <a:t>17.01.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84BB9-20BB-40D6-BD3E-B97D3A221C9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8759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Textfeld 69">
            <a:extLst>
              <a:ext uri="{FF2B5EF4-FFF2-40B4-BE49-F238E27FC236}">
                <a16:creationId xmlns:a16="http://schemas.microsoft.com/office/drawing/2014/main" id="{5923A050-7D06-9675-F910-BABED8D26869}"/>
              </a:ext>
            </a:extLst>
          </p:cNvPr>
          <p:cNvSpPr txBox="1"/>
          <p:nvPr/>
        </p:nvSpPr>
        <p:spPr>
          <a:xfrm>
            <a:off x="124579" y="760234"/>
            <a:ext cx="39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77" name="Textfeld 122">
            <a:extLst>
              <a:ext uri="{FF2B5EF4-FFF2-40B4-BE49-F238E27FC236}">
                <a16:creationId xmlns:a16="http://schemas.microsoft.com/office/drawing/2014/main" id="{9245212D-1585-8E07-C570-2709685477A1}"/>
              </a:ext>
            </a:extLst>
          </p:cNvPr>
          <p:cNvSpPr txBox="1"/>
          <p:nvPr/>
        </p:nvSpPr>
        <p:spPr>
          <a:xfrm>
            <a:off x="2501356" y="760234"/>
            <a:ext cx="39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81" name="Textfeld 6">
            <a:extLst>
              <a:ext uri="{FF2B5EF4-FFF2-40B4-BE49-F238E27FC236}">
                <a16:creationId xmlns:a16="http://schemas.microsoft.com/office/drawing/2014/main" id="{EC47598D-AF44-1AC8-8FD4-E4494DBCA925}"/>
              </a:ext>
            </a:extLst>
          </p:cNvPr>
          <p:cNvSpPr txBox="1"/>
          <p:nvPr/>
        </p:nvSpPr>
        <p:spPr>
          <a:xfrm>
            <a:off x="-2850" y="37581"/>
            <a:ext cx="3279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Source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les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sp>
        <p:nvSpPr>
          <p:cNvPr id="382" name="Textfeld 122">
            <a:extLst>
              <a:ext uri="{FF2B5EF4-FFF2-40B4-BE49-F238E27FC236}">
                <a16:creationId xmlns:a16="http://schemas.microsoft.com/office/drawing/2014/main" id="{B773DCC5-5CC2-5858-184A-77CDDD90EC88}"/>
              </a:ext>
            </a:extLst>
          </p:cNvPr>
          <p:cNvSpPr txBox="1"/>
          <p:nvPr/>
        </p:nvSpPr>
        <p:spPr>
          <a:xfrm>
            <a:off x="124579" y="6183067"/>
            <a:ext cx="39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40733B3-E3DD-1D62-775D-F4C8AC7136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154" y="6491585"/>
            <a:ext cx="1981200" cy="31242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A70FF55-500C-E77D-759A-4CF2077374A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189" y="6491585"/>
            <a:ext cx="1854200" cy="32131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271A6FB-506E-3190-94AF-44DF0B12F2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3040" y="1744640"/>
            <a:ext cx="917409" cy="364358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E89B809-F044-275B-1A63-F722EC6F16E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73" y="1744640"/>
            <a:ext cx="891347" cy="2637555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0E28B2A-12C3-3F74-35CA-73197B129D6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7291" y="1737186"/>
            <a:ext cx="1006023" cy="2679256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666E16F9-7BCE-8D06-7A4A-6A0E0BCEDF00}"/>
              </a:ext>
            </a:extLst>
          </p:cNvPr>
          <p:cNvSpPr txBox="1"/>
          <p:nvPr/>
        </p:nvSpPr>
        <p:spPr>
          <a:xfrm>
            <a:off x="2652707" y="1266510"/>
            <a:ext cx="7537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FLNB 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17848E8-E6A5-CDD3-2794-94CCC44DF7E9}"/>
              </a:ext>
            </a:extLst>
          </p:cNvPr>
          <p:cNvSpPr txBox="1"/>
          <p:nvPr/>
        </p:nvSpPr>
        <p:spPr>
          <a:xfrm>
            <a:off x="3474976" y="1266510"/>
            <a:ext cx="7745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874B3B5-3A17-C361-F067-C8992C3503BB}"/>
              </a:ext>
            </a:extLst>
          </p:cNvPr>
          <p:cNvSpPr txBox="1"/>
          <p:nvPr/>
        </p:nvSpPr>
        <p:spPr>
          <a:xfrm>
            <a:off x="314080" y="1257164"/>
            <a:ext cx="7537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PRMT4 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4AE5A5-DE71-8395-8B55-7C08DB74DEA7}"/>
              </a:ext>
            </a:extLst>
          </p:cNvPr>
          <p:cNvSpPr txBox="1"/>
          <p:nvPr/>
        </p:nvSpPr>
        <p:spPr>
          <a:xfrm>
            <a:off x="1262735" y="1247643"/>
            <a:ext cx="7745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403" name="Textfeld 91">
            <a:extLst>
              <a:ext uri="{FF2B5EF4-FFF2-40B4-BE49-F238E27FC236}">
                <a16:creationId xmlns:a16="http://schemas.microsoft.com/office/drawing/2014/main" id="{9CE7A29C-9D4C-0647-1D28-75E9C6B6C941}"/>
              </a:ext>
            </a:extLst>
          </p:cNvPr>
          <p:cNvSpPr txBox="1"/>
          <p:nvPr/>
        </p:nvSpPr>
        <p:spPr>
          <a:xfrm>
            <a:off x="2626829" y="6288788"/>
            <a:ext cx="1697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2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VINCULIN</a:t>
            </a:r>
          </a:p>
        </p:txBody>
      </p:sp>
      <p:sp>
        <p:nvSpPr>
          <p:cNvPr id="404" name="Textfeld 91">
            <a:extLst>
              <a:ext uri="{FF2B5EF4-FFF2-40B4-BE49-F238E27FC236}">
                <a16:creationId xmlns:a16="http://schemas.microsoft.com/office/drawing/2014/main" id="{1F6ED045-EE10-CE11-5DFC-33AA840603A4}"/>
              </a:ext>
            </a:extLst>
          </p:cNvPr>
          <p:cNvSpPr txBox="1"/>
          <p:nvPr/>
        </p:nvSpPr>
        <p:spPr>
          <a:xfrm>
            <a:off x="833510" y="6288788"/>
            <a:ext cx="11405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2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PRMT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5033E7-4EFD-5245-B6FE-23CF89DCCC3F}"/>
              </a:ext>
            </a:extLst>
          </p:cNvPr>
          <p:cNvPicPr>
            <a:picLocks/>
          </p:cNvPicPr>
          <p:nvPr/>
        </p:nvPicPr>
        <p:blipFill>
          <a:blip r:embed="rId8"/>
          <a:srcRect l="58448" r="28626"/>
          <a:stretch/>
        </p:blipFill>
        <p:spPr>
          <a:xfrm>
            <a:off x="3577442" y="1737186"/>
            <a:ext cx="615950" cy="357595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E6121BC-E600-9C0D-2AA8-68B6B492224A}"/>
              </a:ext>
            </a:extLst>
          </p:cNvPr>
          <p:cNvSpPr txBox="1"/>
          <p:nvPr/>
        </p:nvSpPr>
        <p:spPr>
          <a:xfrm>
            <a:off x="4825320" y="1247347"/>
            <a:ext cx="934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CHASERR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8A583A-A888-E8D0-830F-89923D2FCCC7}"/>
              </a:ext>
            </a:extLst>
          </p:cNvPr>
          <p:cNvSpPr txBox="1"/>
          <p:nvPr/>
        </p:nvSpPr>
        <p:spPr>
          <a:xfrm>
            <a:off x="5878787" y="1266510"/>
            <a:ext cx="7537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DE" sz="1200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  <a:p>
            <a:pPr algn="ctr"/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RT-PCR</a:t>
            </a:r>
          </a:p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 the same as in panel E. </a:t>
            </a:r>
          </a:p>
        </p:txBody>
      </p:sp>
      <p:sp>
        <p:nvSpPr>
          <p:cNvPr id="11" name="Textfeld 122">
            <a:extLst>
              <a:ext uri="{FF2B5EF4-FFF2-40B4-BE49-F238E27FC236}">
                <a16:creationId xmlns:a16="http://schemas.microsoft.com/office/drawing/2014/main" id="{30289F15-F6B4-637E-60CA-150B79FF9522}"/>
              </a:ext>
            </a:extLst>
          </p:cNvPr>
          <p:cNvSpPr txBox="1"/>
          <p:nvPr/>
        </p:nvSpPr>
        <p:spPr>
          <a:xfrm>
            <a:off x="4603170" y="760234"/>
            <a:ext cx="3934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6CEE9C9-89AB-4310-D689-84F656D14722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-1" r="81411"/>
          <a:stretch/>
        </p:blipFill>
        <p:spPr>
          <a:xfrm>
            <a:off x="2613080" y="1751511"/>
            <a:ext cx="886335" cy="3575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8346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60</TotalTime>
  <Words>32</Words>
  <Application>Microsoft Macintosh PowerPoint</Application>
  <PresentationFormat>A4 Paper (210x297 mm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</dc:creator>
  <cp:lastModifiedBy>Microsoft Office User</cp:lastModifiedBy>
  <cp:revision>119</cp:revision>
  <cp:lastPrinted>2024-12-24T00:14:48Z</cp:lastPrinted>
  <dcterms:created xsi:type="dcterms:W3CDTF">2024-04-04T09:28:53Z</dcterms:created>
  <dcterms:modified xsi:type="dcterms:W3CDTF">2025-01-17T13:54:37Z</dcterms:modified>
</cp:coreProperties>
</file>